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09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62" userDrawn="1">
          <p15:clr>
            <a:srgbClr val="A4A3A4"/>
          </p15:clr>
        </p15:guide>
        <p15:guide id="2" pos="23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1DFDCD1-EF6B-3F80-07E7-35A56DD59C0E}" name="Charleen Chan" initials="CC" userId="S::charleen.chan@icr.ac.uk::73a26ce7-f665-4248-b705-b0b5a6e7a5b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  <a:srgbClr val="FF6699"/>
    <a:srgbClr val="CC00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82"/>
    <p:restoredTop sz="96192"/>
  </p:normalViewPr>
  <p:slideViewPr>
    <p:cSldViewPr snapToGrid="0">
      <p:cViewPr>
        <p:scale>
          <a:sx n="303" d="100"/>
          <a:sy n="303" d="100"/>
        </p:scale>
        <p:origin x="144" y="-5872"/>
      </p:cViewPr>
      <p:guideLst>
        <p:guide orient="horz" pos="2462"/>
        <p:guide pos="2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4BE0-296C-2D4A-8E47-23328EA7FFFE}" type="datetimeFigureOut">
              <a:rPr lang="en-US" smtClean="0"/>
              <a:t>10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9F04B6-F912-E44D-B4F8-91F0A2777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78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9F04B6-F912-E44D-B4F8-91F0A27773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387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936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560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420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86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8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44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57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527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618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11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07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51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id="{3F9D1953-E384-1CF1-50B7-3B22B4040CAD}"/>
              </a:ext>
            </a:extLst>
          </p:cNvPr>
          <p:cNvSpPr txBox="1"/>
          <p:nvPr/>
        </p:nvSpPr>
        <p:spPr>
          <a:xfrm>
            <a:off x="167621" y="4814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B4AD867-C21D-1482-E175-65621D5A8478}"/>
              </a:ext>
            </a:extLst>
          </p:cNvPr>
          <p:cNvSpPr txBox="1"/>
          <p:nvPr/>
        </p:nvSpPr>
        <p:spPr>
          <a:xfrm>
            <a:off x="5883966" y="67753"/>
            <a:ext cx="123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B694ACB-2E89-DA9A-B889-B56972FA0630}"/>
              </a:ext>
            </a:extLst>
          </p:cNvPr>
          <p:cNvSpPr txBox="1"/>
          <p:nvPr/>
        </p:nvSpPr>
        <p:spPr>
          <a:xfrm>
            <a:off x="3498649" y="48597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F1621E6-675F-3BB3-1A41-E0346672922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5653"/>
          <a:stretch>
            <a:fillRect/>
          </a:stretch>
        </p:blipFill>
        <p:spPr>
          <a:xfrm>
            <a:off x="564388" y="452438"/>
            <a:ext cx="2024435" cy="350165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9405D7A-E38B-37D9-955A-11A76EF83CC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4724"/>
          <a:stretch>
            <a:fillRect/>
          </a:stretch>
        </p:blipFill>
        <p:spPr>
          <a:xfrm>
            <a:off x="3843928" y="423410"/>
            <a:ext cx="2024435" cy="353613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B72094B-558F-9028-BB2D-9CF3F472AB5E}"/>
              </a:ext>
            </a:extLst>
          </p:cNvPr>
          <p:cNvSpPr txBox="1"/>
          <p:nvPr/>
        </p:nvSpPr>
        <p:spPr>
          <a:xfrm>
            <a:off x="374763" y="4106408"/>
            <a:ext cx="601774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6. Comparison of our dataset with published gene signatures predicting immunotherapy responsiveness and prognosis in human SCCHN</a:t>
            </a:r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ignature gene sets from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Wang et al., Front Genet 2022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[Ref. 41] and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Zhu et al., Front Genet 2022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[Ref. 42]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model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MOC1 model. Signature scores across treatment conditions are shown as Z-scores of mean GSVA signature scores per condition (5 tumours/group).</a:t>
            </a:r>
          </a:p>
        </p:txBody>
      </p:sp>
    </p:spTree>
    <p:extLst>
      <p:ext uri="{BB962C8B-B14F-4D97-AF65-F5344CB8AC3E}">
        <p14:creationId xmlns:p14="http://schemas.microsoft.com/office/powerpoint/2010/main" val="732081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97</TotalTime>
  <Words>86</Words>
  <Application>Microsoft Macintosh PowerPoint</Application>
  <PresentationFormat>A4 Paper (210x297 mm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nuel Patin</dc:creator>
  <cp:lastModifiedBy>Charleen Chan</cp:lastModifiedBy>
  <cp:revision>497</cp:revision>
  <cp:lastPrinted>2025-09-17T11:02:21Z</cp:lastPrinted>
  <dcterms:created xsi:type="dcterms:W3CDTF">2019-11-04T10:33:30Z</dcterms:created>
  <dcterms:modified xsi:type="dcterms:W3CDTF">2025-10-09T08:59:57Z</dcterms:modified>
</cp:coreProperties>
</file>